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4810" y="2257425"/>
            <a:ext cx="6304280" cy="318960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600075" y="6243320"/>
            <a:ext cx="6089015" cy="645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3.Gene Ontology (GO) enrichment analysis of the 71 continuously lengthened genes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4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